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  <p:sldId id="258" r:id="rId6"/>
    <p:sldId id="262" r:id="rId7"/>
  </p:sldIdLst>
  <p:sldSz cx="12192000" cy="6858000"/>
  <p:notesSz cx="6858000" cy="9144000"/>
  <p:defaultTextStyle>
    <a:defPPr>
      <a:defRPr lang="sr-Latn-R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FB94ED4-3BDB-429B-A667-1438DB1F0A82}" v="1" dt="2022-11-24T12:50:44.34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7" autoAdjust="0"/>
    <p:restoredTop sz="94660"/>
  </p:normalViewPr>
  <p:slideViewPr>
    <p:cSldViewPr snapToGrid="0">
      <p:cViewPr varScale="1">
        <p:scale>
          <a:sx n="82" d="100"/>
          <a:sy n="82" d="100"/>
        </p:scale>
        <p:origin x="49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van Sabol" userId="4daa963d-6527-499d-a041-90a6af3ac5df" providerId="ADAL" clId="{27C9156E-47BF-49CC-87B6-1A964D7228A3}"/>
    <pc:docChg chg="undo custSel modSld">
      <pc:chgData name="Ivan Sabol" userId="4daa963d-6527-499d-a041-90a6af3ac5df" providerId="ADAL" clId="{27C9156E-47BF-49CC-87B6-1A964D7228A3}" dt="2022-11-22T09:59:26.213" v="2" actId="1076"/>
      <pc:docMkLst>
        <pc:docMk/>
      </pc:docMkLst>
      <pc:sldChg chg="delSp modSp mod">
        <pc:chgData name="Ivan Sabol" userId="4daa963d-6527-499d-a041-90a6af3ac5df" providerId="ADAL" clId="{27C9156E-47BF-49CC-87B6-1A964D7228A3}" dt="2022-11-22T09:59:26.213" v="2" actId="1076"/>
        <pc:sldMkLst>
          <pc:docMk/>
          <pc:sldMk cId="2564957912" sldId="257"/>
        </pc:sldMkLst>
        <pc:spChg chg="del">
          <ac:chgData name="Ivan Sabol" userId="4daa963d-6527-499d-a041-90a6af3ac5df" providerId="ADAL" clId="{27C9156E-47BF-49CC-87B6-1A964D7228A3}" dt="2022-11-22T09:59:15.279" v="0" actId="478"/>
          <ac:spMkLst>
            <pc:docMk/>
            <pc:sldMk cId="2564957912" sldId="257"/>
            <ac:spMk id="6" creationId="{00000000-0000-0000-0000-000000000000}"/>
          </ac:spMkLst>
        </pc:spChg>
        <pc:picChg chg="mod">
          <ac:chgData name="Ivan Sabol" userId="4daa963d-6527-499d-a041-90a6af3ac5df" providerId="ADAL" clId="{27C9156E-47BF-49CC-87B6-1A964D7228A3}" dt="2022-11-22T09:59:26.213" v="2" actId="1076"/>
          <ac:picMkLst>
            <pc:docMk/>
            <pc:sldMk cId="2564957912" sldId="257"/>
            <ac:picMk id="4" creationId="{00000000-0000-0000-0000-000000000000}"/>
          </ac:picMkLst>
        </pc:picChg>
        <pc:picChg chg="mod">
          <ac:chgData name="Ivan Sabol" userId="4daa963d-6527-499d-a041-90a6af3ac5df" providerId="ADAL" clId="{27C9156E-47BF-49CC-87B6-1A964D7228A3}" dt="2022-11-22T09:59:26.213" v="2" actId="1076"/>
          <ac:picMkLst>
            <pc:docMk/>
            <pc:sldMk cId="2564957912" sldId="257"/>
            <ac:picMk id="5" creationId="{00000000-0000-0000-0000-000000000000}"/>
          </ac:picMkLst>
        </pc:picChg>
      </pc:sldChg>
    </pc:docChg>
  </pc:docChgLst>
  <pc:docChgLst>
    <pc:chgData name="Ivan Sabol" userId="4daa963d-6527-499d-a041-90a6af3ac5df" providerId="ADAL" clId="{6FB94ED4-3BDB-429B-A667-1438DB1F0A82}"/>
    <pc:docChg chg="modSld">
      <pc:chgData name="Ivan Sabol" userId="4daa963d-6527-499d-a041-90a6af3ac5df" providerId="ADAL" clId="{6FB94ED4-3BDB-429B-A667-1438DB1F0A82}" dt="2022-11-24T12:52:35.850" v="165" actId="14100"/>
      <pc:docMkLst>
        <pc:docMk/>
      </pc:docMkLst>
      <pc:sldChg chg="addSp modSp mod">
        <pc:chgData name="Ivan Sabol" userId="4daa963d-6527-499d-a041-90a6af3ac5df" providerId="ADAL" clId="{6FB94ED4-3BDB-429B-A667-1438DB1F0A82}" dt="2022-11-24T12:52:35.850" v="165" actId="14100"/>
        <pc:sldMkLst>
          <pc:docMk/>
          <pc:sldMk cId="2564957912" sldId="257"/>
        </pc:sldMkLst>
        <pc:spChg chg="add mod">
          <ac:chgData name="Ivan Sabol" userId="4daa963d-6527-499d-a041-90a6af3ac5df" providerId="ADAL" clId="{6FB94ED4-3BDB-429B-A667-1438DB1F0A82}" dt="2022-11-24T12:52:25.554" v="164" actId="20577"/>
          <ac:spMkLst>
            <pc:docMk/>
            <pc:sldMk cId="2564957912" sldId="257"/>
            <ac:spMk id="2" creationId="{F290BF28-DC5F-3564-8896-10321DFA6235}"/>
          </ac:spMkLst>
        </pc:spChg>
        <pc:picChg chg="mod">
          <ac:chgData name="Ivan Sabol" userId="4daa963d-6527-499d-a041-90a6af3ac5df" providerId="ADAL" clId="{6FB94ED4-3BDB-429B-A667-1438DB1F0A82}" dt="2022-11-24T12:52:35.850" v="165" actId="14100"/>
          <ac:picMkLst>
            <pc:docMk/>
            <pc:sldMk cId="2564957912" sldId="257"/>
            <ac:picMk id="4" creationId="{00000000-0000-0000-0000-000000000000}"/>
          </ac:picMkLst>
        </pc:picChg>
        <pc:picChg chg="mod">
          <ac:chgData name="Ivan Sabol" userId="4daa963d-6527-499d-a041-90a6af3ac5df" providerId="ADAL" clId="{6FB94ED4-3BDB-429B-A667-1438DB1F0A82}" dt="2022-11-24T12:52:35.850" v="165" actId="14100"/>
          <ac:picMkLst>
            <pc:docMk/>
            <pc:sldMk cId="2564957912" sldId="257"/>
            <ac:picMk id="5" creationId="{00000000-0000-0000-0000-000000000000}"/>
          </ac:picMkLst>
        </pc:picChg>
        <pc:picChg chg="mod">
          <ac:chgData name="Ivan Sabol" userId="4daa963d-6527-499d-a041-90a6af3ac5df" providerId="ADAL" clId="{6FB94ED4-3BDB-429B-A667-1438DB1F0A82}" dt="2022-11-24T12:52:35.850" v="165" actId="14100"/>
          <ac:picMkLst>
            <pc:docMk/>
            <pc:sldMk cId="2564957912" sldId="257"/>
            <ac:picMk id="6" creationId="{00000000-0000-0000-0000-000000000000}"/>
          </ac:picMkLst>
        </pc:picChg>
        <pc:picChg chg="mod">
          <ac:chgData name="Ivan Sabol" userId="4daa963d-6527-499d-a041-90a6af3ac5df" providerId="ADAL" clId="{6FB94ED4-3BDB-429B-A667-1438DB1F0A82}" dt="2022-11-24T12:52:35.850" v="165" actId="14100"/>
          <ac:picMkLst>
            <pc:docMk/>
            <pc:sldMk cId="2564957912" sldId="257"/>
            <ac:picMk id="7" creationId="{00000000-0000-0000-0000-00000000000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174BE-EA81-48CB-B95D-1CB068B30E30}" type="datetimeFigureOut">
              <a:rPr lang="hr-HR" smtClean="0"/>
              <a:t>8.2.2023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93329-44B2-4BCE-B93B-F6325F52C81A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579227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174BE-EA81-48CB-B95D-1CB068B30E30}" type="datetimeFigureOut">
              <a:rPr lang="hr-HR" smtClean="0"/>
              <a:t>8.2.2023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93329-44B2-4BCE-B93B-F6325F52C81A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321596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174BE-EA81-48CB-B95D-1CB068B30E30}" type="datetimeFigureOut">
              <a:rPr lang="hr-HR" smtClean="0"/>
              <a:t>8.2.2023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93329-44B2-4BCE-B93B-F6325F52C81A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987116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174BE-EA81-48CB-B95D-1CB068B30E30}" type="datetimeFigureOut">
              <a:rPr lang="hr-HR" smtClean="0"/>
              <a:t>8.2.2023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93329-44B2-4BCE-B93B-F6325F52C81A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3773493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174BE-EA81-48CB-B95D-1CB068B30E30}" type="datetimeFigureOut">
              <a:rPr lang="hr-HR" smtClean="0"/>
              <a:t>8.2.2023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93329-44B2-4BCE-B93B-F6325F52C81A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69135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174BE-EA81-48CB-B95D-1CB068B30E30}" type="datetimeFigureOut">
              <a:rPr lang="hr-HR" smtClean="0"/>
              <a:t>8.2.2023.</a:t>
            </a:fld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93329-44B2-4BCE-B93B-F6325F52C81A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4264009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174BE-EA81-48CB-B95D-1CB068B30E30}" type="datetimeFigureOut">
              <a:rPr lang="hr-HR" smtClean="0"/>
              <a:t>8.2.2023.</a:t>
            </a:fld>
            <a:endParaRPr lang="hr-H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93329-44B2-4BCE-B93B-F6325F52C81A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465798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174BE-EA81-48CB-B95D-1CB068B30E30}" type="datetimeFigureOut">
              <a:rPr lang="hr-HR" smtClean="0"/>
              <a:t>8.2.2023.</a:t>
            </a:fld>
            <a:endParaRPr lang="hr-H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93329-44B2-4BCE-B93B-F6325F52C81A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4240507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174BE-EA81-48CB-B95D-1CB068B30E30}" type="datetimeFigureOut">
              <a:rPr lang="hr-HR" smtClean="0"/>
              <a:t>8.2.2023.</a:t>
            </a:fld>
            <a:endParaRPr lang="hr-H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93329-44B2-4BCE-B93B-F6325F52C81A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70301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174BE-EA81-48CB-B95D-1CB068B30E30}" type="datetimeFigureOut">
              <a:rPr lang="hr-HR" smtClean="0"/>
              <a:t>8.2.2023.</a:t>
            </a:fld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93329-44B2-4BCE-B93B-F6325F52C81A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241823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r-H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2174BE-EA81-48CB-B95D-1CB068B30E30}" type="datetimeFigureOut">
              <a:rPr lang="hr-HR" smtClean="0"/>
              <a:t>8.2.2023.</a:t>
            </a:fld>
            <a:endParaRPr lang="hr-H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r-H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93329-44B2-4BCE-B93B-F6325F52C81A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1641432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hr-H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r-H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174BE-EA81-48CB-B95D-1CB068B30E30}" type="datetimeFigureOut">
              <a:rPr lang="hr-HR" smtClean="0"/>
              <a:t>8.2.2023.</a:t>
            </a:fld>
            <a:endParaRPr lang="hr-H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r-H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C93329-44B2-4BCE-B93B-F6325F52C81A}" type="slidenum">
              <a:rPr lang="hr-HR" smtClean="0"/>
              <a:t>‹#›</a:t>
            </a:fld>
            <a:endParaRPr lang="hr-HR"/>
          </a:p>
        </p:txBody>
      </p:sp>
    </p:spTree>
    <p:extLst>
      <p:ext uri="{BB962C8B-B14F-4D97-AF65-F5344CB8AC3E}">
        <p14:creationId xmlns:p14="http://schemas.microsoft.com/office/powerpoint/2010/main" val="3052528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r-Latn-R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8.png"/><Relationship Id="rId4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sz="half"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5308" y="782378"/>
            <a:ext cx="4024476" cy="2857962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742" y="786063"/>
            <a:ext cx="3869688" cy="2902266"/>
          </a:xfrm>
          <a:prstGeom prst="rect">
            <a:avLst/>
          </a:prstGeom>
        </p:spPr>
      </p:pic>
      <p:pic>
        <p:nvPicPr>
          <p:cNvPr id="6" name="Content Placeholder 5"/>
          <p:cNvPicPr>
            <a:picLocks noGrp="1" noChangeAspect="1"/>
          </p:cNvPicPr>
          <p:nvPr>
            <p:ph sz="half" idx="2"/>
          </p:nvPr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5308" y="3926041"/>
            <a:ext cx="4024476" cy="2857961"/>
          </a:xfrm>
        </p:spPr>
      </p:pic>
      <p:pic>
        <p:nvPicPr>
          <p:cNvPr id="7" name="Content Placeholder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162" y="3983830"/>
            <a:ext cx="3869688" cy="290226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290BF28-DC5F-3564-8896-10321DFA6235}"/>
              </a:ext>
            </a:extLst>
          </p:cNvPr>
          <p:cNvSpPr txBox="1"/>
          <p:nvPr/>
        </p:nvSpPr>
        <p:spPr>
          <a:xfrm>
            <a:off x="336884" y="0"/>
            <a:ext cx="115182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r-HR" dirty="0" err="1"/>
              <a:t>Supplementary</a:t>
            </a:r>
            <a:r>
              <a:rPr lang="hr-HR" dirty="0"/>
              <a:t> figure 1. Expression (left) and survival effects (right) of miRNA -9,-21,-29a,-100 and -106b in the publicly available TCGA dataset (n=526)</a:t>
            </a:r>
            <a:r>
              <a:rPr lang="en-US" dirty="0"/>
              <a:t> [40,41]</a:t>
            </a:r>
            <a:r>
              <a:rPr lang="hr-HR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5649579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453" y="80909"/>
            <a:ext cx="4500000" cy="3375000"/>
          </a:xfrm>
          <a:prstGeom prst="rect">
            <a:avLst/>
          </a:prstGeom>
        </p:spPr>
      </p:pic>
      <p:pic>
        <p:nvPicPr>
          <p:cNvPr id="9" name="Content Placeholder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7276" y="115093"/>
            <a:ext cx="4680000" cy="3323478"/>
          </a:xfrm>
          <a:prstGeom prst="rect">
            <a:avLst/>
          </a:prstGeom>
        </p:spPr>
      </p:pic>
      <p:pic>
        <p:nvPicPr>
          <p:cNvPr id="10" name="Content Placeholder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836" y="3510984"/>
            <a:ext cx="4500000" cy="3375000"/>
          </a:xfrm>
          <a:prstGeom prst="rect">
            <a:avLst/>
          </a:prstGeom>
        </p:spPr>
      </p:pic>
      <p:pic>
        <p:nvPicPr>
          <p:cNvPr id="11" name="Content Placeholder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2199" y="3528785"/>
            <a:ext cx="4680000" cy="33234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5511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/>
          <p:cNvPicPr>
            <a:picLocks noGrp="1" noChangeAspect="1"/>
          </p:cNvPicPr>
          <p:nvPr>
            <p:ph sz="half"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555" y="406450"/>
            <a:ext cx="4680000" cy="3510000"/>
          </a:xfrm>
        </p:spPr>
      </p:pic>
      <p:pic>
        <p:nvPicPr>
          <p:cNvPr id="6" name="Content Placeholder 5"/>
          <p:cNvPicPr>
            <a:picLocks noGrp="1" noChangeAspect="1"/>
          </p:cNvPicPr>
          <p:nvPr>
            <p:ph sz="half" idx="2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2936" y="499711"/>
            <a:ext cx="4680000" cy="3323478"/>
          </a:xfrm>
        </p:spPr>
      </p:pic>
    </p:spTree>
    <p:extLst>
      <p:ext uri="{BB962C8B-B14F-4D97-AF65-F5344CB8AC3E}">
        <p14:creationId xmlns:p14="http://schemas.microsoft.com/office/powerpoint/2010/main" val="1973036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2FD31DC98FDA0468E4E7C96FC4D82C4" ma:contentTypeVersion="14" ma:contentTypeDescription="Create a new document." ma:contentTypeScope="" ma:versionID="4f3a6fd8131a88fac451df1ff3bde664">
  <xsd:schema xmlns:xsd="http://www.w3.org/2001/XMLSchema" xmlns:xs="http://www.w3.org/2001/XMLSchema" xmlns:p="http://schemas.microsoft.com/office/2006/metadata/properties" xmlns:ns2="17b1b609-9c1f-45a1-80ad-9e1c0c07fc0e" xmlns:ns3="e906dc67-57b9-4d7e-b651-9578f0dd2a57" targetNamespace="http://schemas.microsoft.com/office/2006/metadata/properties" ma:root="true" ma:fieldsID="2a478849751f24639b2d4c447844fe32" ns2:_="" ns3:_="">
    <xsd:import namespace="17b1b609-9c1f-45a1-80ad-9e1c0c07fc0e"/>
    <xsd:import namespace="e906dc67-57b9-4d7e-b651-9578f0dd2a57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KeyPoints" minOccurs="0"/>
                <xsd:element ref="ns2:MediaServiceKeyPoints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7b1b609-9c1f-45a1-80ad-9e1c0c07fc0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7" nillable="true" ma:taxonomy="true" ma:internalName="lcf76f155ced4ddcb4097134ff3c332f" ma:taxonomyFieldName="MediaServiceImageTags" ma:displayName="Image Tags" ma:readOnly="false" ma:fieldId="{5cf76f15-5ced-4ddc-b409-7134ff3c332f}" ma:taxonomyMulti="true" ma:sspId="8d93be76-319f-4aed-ae45-5945708fe5a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20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906dc67-57b9-4d7e-b651-9578f0dd2a57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8" nillable="true" ma:displayName="Taxonomy Catch All Column" ma:hidden="true" ma:list="{b4cd580d-8648-491e-8d84-7492f43051eb}" ma:internalName="TaxCatchAll" ma:showField="CatchAllData" ma:web="e906dc67-57b9-4d7e-b651-9578f0dd2a5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e906dc67-57b9-4d7e-b651-9578f0dd2a57" xsi:nil="true"/>
    <lcf76f155ced4ddcb4097134ff3c332f xmlns="17b1b609-9c1f-45a1-80ad-9e1c0c07fc0e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16DC8EE-1FCD-4368-81C1-44F16F1A56A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7b1b609-9c1f-45a1-80ad-9e1c0c07fc0e"/>
    <ds:schemaRef ds:uri="e906dc67-57b9-4d7e-b651-9578f0dd2a5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EAACEAF-C9AE-4519-8F01-B7CB75BB6882}">
  <ds:schemaRefs>
    <ds:schemaRef ds:uri="http://schemas.microsoft.com/office/2006/documentManagement/typ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17b1b609-9c1f-45a1-80ad-9e1c0c07fc0e"/>
    <ds:schemaRef ds:uri="e906dc67-57b9-4d7e-b651-9578f0dd2a57"/>
    <ds:schemaRef ds:uri="http://purl.org/dc/elements/1.1/"/>
    <ds:schemaRef ds:uri="http://schemas.microsoft.com/office/2006/metadata/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D31E4891-ECEB-4ABD-8ACA-BED7FC55AE7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41</Words>
  <Application>Microsoft Office PowerPoint</Application>
  <PresentationFormat>Widescreen</PresentationFormat>
  <Paragraphs>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MDPI</cp:lastModifiedBy>
  <cp:revision>6</cp:revision>
  <dcterms:created xsi:type="dcterms:W3CDTF">2022-10-27T12:05:52Z</dcterms:created>
  <dcterms:modified xsi:type="dcterms:W3CDTF">2023-02-08T08:47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2FD31DC98FDA0468E4E7C96FC4D82C4</vt:lpwstr>
  </property>
  <property fmtid="{D5CDD505-2E9C-101B-9397-08002B2CF9AE}" pid="3" name="MediaServiceImageTags">
    <vt:lpwstr/>
  </property>
</Properties>
</file>